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3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1" autoAdjust="0"/>
    <p:restoredTop sz="94660"/>
  </p:normalViewPr>
  <p:slideViewPr>
    <p:cSldViewPr snapToGrid="0">
      <p:cViewPr varScale="1">
        <p:scale>
          <a:sx n="93" d="100"/>
          <a:sy n="93" d="100"/>
        </p:scale>
        <p:origin x="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5351F8-4C01-4A96-9705-756BF1E1DE6A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F04474-3380-41BE-AB13-1F56D992C5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351255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F04474-3380-41BE-AB13-1F56D992C5EC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32968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1A125-FED6-3212-81C2-D471A026AC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E452BC-DF09-DDC3-63AD-A43D203ED8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2E6BDA-761D-ECD6-4533-9B206C142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3167DB-F70B-CAC6-EC84-22E06F9B5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62A6E3-BC93-DF20-6519-EA9F1854A6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21497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758E9-2EAB-6C32-A67B-12CBDFA82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30A93F-6F20-B2C7-C411-D9DDFABBBC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37D3C-F6F5-31DF-B53A-A6AB31BCB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3EA8FE-CE5B-3DE6-0316-0E69F1070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B42AD-AAC7-19E9-5D50-47373C15E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1182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20FBEB-840F-A06A-7178-DA2D85BCD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CE4445-50FE-DB80-D33E-E206D3AF5A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5D045-5383-560C-4AF9-4E55ED3FB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D78C4F-6F7B-E695-8564-CF6C87A0F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808F5-77A8-2B32-5D75-B4D6A8529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16607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EDAE79-5467-7F31-B1F7-B1107A6F0F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E9E613-B01B-7E69-2410-14112A8754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5DDCA0-6151-E9D1-ABD9-93F0CD501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06B02D-F9B8-45C2-5A23-F4EEBC7AF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16DE2-BC88-DB60-AA4E-CC2866125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06389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67B30-09C7-0D02-D51C-57675814F1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47C41E-101F-463D-1690-379C0FCBC0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6BAC3B-340C-16ED-9399-0EC942F15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43EF7F-1798-6C1F-4DAC-88CCEA79F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EF4E2E-A582-D403-AC46-56298D3A2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080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533E5-1EA4-CAFA-16FE-3D1B80963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173D0B-65A7-EA95-9F34-A446CC5568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411DFC-5581-D0A4-4627-FF774C5DAE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E38894-3DA9-3D92-35F7-F9543A4C8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9DCBE9-9F65-9DF8-E2DB-DC00E1F1C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F6CDBF-821E-15D7-198E-05111E939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1442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A08CF4-5E4D-5F2E-F72F-6C596944D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C7ADB5-1C46-D13A-002B-A3612F06F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C6F848-BE19-1449-933C-F2E710224A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2706BB-4997-4FBC-3220-72713887B5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B071A7-CA35-94E5-C57C-A96528E391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B55C7C-2C92-726A-0BE9-D52F59497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944FB0-D654-2FD6-3883-7DB566E9B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868924-7AE9-5684-69FD-8160DFFDB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867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83989-E2D7-FEB6-78D5-FA3543327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4A82702-9437-056F-7518-5E8C108A1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621193-B88C-7E40-3315-F234747F1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F6ED91E-69C0-6E07-6072-46DFAAB88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06593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8C62D6-00D4-6DE1-2A5F-005CCF14B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3AD6B6-C9F4-D022-8749-AB9A6AE6F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C257D8-93DA-89D4-8BD7-2C3B8B7EA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70228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F40C6-B680-2B43-66BD-CA51484739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B8FBC3-E8A3-A0AC-0480-BF92F518CA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AC6C93-C755-4D4C-A346-6398CBC65A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5ADAD2-ABCE-B495-BED1-958BFA0C8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5EF550-9849-DE14-3A16-158B1E90C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F792C1-4486-47AE-45A2-BB538D36C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3997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180B27-3F70-94D9-5A68-E51FF2414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D25FDC-1DC4-7FBF-6ABF-55D6E27A08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71FED9-40FC-58CB-0360-B6A34C665C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7BF232-A49A-F412-F768-4B8FBE58D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E33004-5DE5-EC7A-2861-B05E300CF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B653E-0B19-B75B-D5DD-38F63267C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2310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79BF09-5AAD-8D30-64E7-5FCBE5993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C8825C-2B9B-2144-869D-46060218E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CA3068-EFEC-149F-6F77-31E5BAB075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6EE646-4BDB-45DD-8283-A6737317671E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E83CEA-AA5B-CCAB-744A-E79A1E23FE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A7D660-A148-C06F-B7FE-18AFD22392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418684-F5F4-47E0-A395-7D19D84EC4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18352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D50 3D-VOR1 CD31+NG2 18-08">
            <a:hlinkClick r:id="" action="ppaction://media"/>
            <a:extLst>
              <a:ext uri="{FF2B5EF4-FFF2-40B4-BE49-F238E27FC236}">
                <a16:creationId xmlns:a16="http://schemas.microsoft.com/office/drawing/2014/main" id="{F23C0EF8-6AC2-687C-C98A-B5B23FD9712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249615" y="135104"/>
            <a:ext cx="7898837" cy="5924131"/>
          </a:xfrm>
          <a:prstGeom prst="rect">
            <a:avLst/>
          </a:prstGeom>
          <a:ln w="12700">
            <a:solidFill>
              <a:schemeClr val="tx1"/>
            </a:solidFill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198C263-7F02-39D0-77AF-E3F380922728}"/>
              </a:ext>
            </a:extLst>
          </p:cNvPr>
          <p:cNvSpPr txBox="1"/>
          <p:nvPr/>
        </p:nvSpPr>
        <p:spPr>
          <a:xfrm>
            <a:off x="2448471" y="135104"/>
            <a:ext cx="77457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n-AU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</a:p>
          <a:p>
            <a:r>
              <a:rPr lang="en-AU" b="1" dirty="0">
                <a:solidFill>
                  <a:srgbClr val="F01D2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G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46B5D3-B828-88BA-CA5E-7EFF3E722FA0}"/>
              </a:ext>
            </a:extLst>
          </p:cNvPr>
          <p:cNvSpPr txBox="1"/>
          <p:nvPr/>
        </p:nvSpPr>
        <p:spPr>
          <a:xfrm>
            <a:off x="247049" y="6135452"/>
            <a:ext cx="11645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Video 1</a:t>
            </a:r>
            <a:r>
              <a:rPr lang="en-AU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Whole mount immunofluorescence – Human vascular organoid.</a:t>
            </a:r>
          </a:p>
        </p:txBody>
      </p:sp>
    </p:spTree>
    <p:extLst>
      <p:ext uri="{BB962C8B-B14F-4D97-AF65-F5344CB8AC3E}">
        <p14:creationId xmlns:p14="http://schemas.microsoft.com/office/powerpoint/2010/main" val="13182420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33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6</Words>
  <Application>Microsoft Office PowerPoint</Application>
  <PresentationFormat>Widescreen</PresentationFormat>
  <Paragraphs>5</Paragraphs>
  <Slides>1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tchell Mostina</dc:creator>
  <cp:lastModifiedBy>Abbas Shafiee</cp:lastModifiedBy>
  <cp:revision>3</cp:revision>
  <dcterms:created xsi:type="dcterms:W3CDTF">2025-06-23T01:19:26Z</dcterms:created>
  <dcterms:modified xsi:type="dcterms:W3CDTF">2025-07-11T07:15:20Z</dcterms:modified>
</cp:coreProperties>
</file>